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5929" r:id="rId2"/>
    <p:sldId id="5930" r:id="rId3"/>
  </p:sldIdLst>
  <p:sldSz cx="64008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02"/>
    <p:restoredTop sz="96327"/>
  </p:normalViewPr>
  <p:slideViewPr>
    <p:cSldViewPr snapToGrid="0">
      <p:cViewPr varScale="1">
        <p:scale>
          <a:sx n="107" d="100"/>
          <a:sy n="107" d="100"/>
        </p:scale>
        <p:origin x="342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197FFD-F7D0-6B44-8E50-F054F3374A90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28850" y="1143000"/>
            <a:ext cx="2400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E3D2CB-36E4-CC4C-8389-D626B50AD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6055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14CA91-3E16-404D-B73B-C44D15C1A8C0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88170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619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244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030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450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065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424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519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591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865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333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270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359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26" Type="http://schemas.openxmlformats.org/officeDocument/2006/relationships/image" Target="../media/image24.emf"/><Relationship Id="rId39" Type="http://schemas.openxmlformats.org/officeDocument/2006/relationships/image" Target="../media/image37.emf"/><Relationship Id="rId21" Type="http://schemas.openxmlformats.org/officeDocument/2006/relationships/image" Target="../media/image19.emf"/><Relationship Id="rId34" Type="http://schemas.openxmlformats.org/officeDocument/2006/relationships/image" Target="../media/image32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5" Type="http://schemas.openxmlformats.org/officeDocument/2006/relationships/image" Target="../media/image23.emf"/><Relationship Id="rId33" Type="http://schemas.openxmlformats.org/officeDocument/2006/relationships/image" Target="../media/image31.emf"/><Relationship Id="rId38" Type="http://schemas.openxmlformats.org/officeDocument/2006/relationships/image" Target="../media/image36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29" Type="http://schemas.openxmlformats.org/officeDocument/2006/relationships/image" Target="../media/image2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24" Type="http://schemas.openxmlformats.org/officeDocument/2006/relationships/image" Target="../media/image22.emf"/><Relationship Id="rId32" Type="http://schemas.openxmlformats.org/officeDocument/2006/relationships/image" Target="../media/image30.emf"/><Relationship Id="rId37" Type="http://schemas.openxmlformats.org/officeDocument/2006/relationships/image" Target="../media/image35.emf"/><Relationship Id="rId40" Type="http://schemas.openxmlformats.org/officeDocument/2006/relationships/image" Target="../media/image38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23" Type="http://schemas.openxmlformats.org/officeDocument/2006/relationships/image" Target="../media/image21.emf"/><Relationship Id="rId28" Type="http://schemas.openxmlformats.org/officeDocument/2006/relationships/image" Target="../media/image26.emf"/><Relationship Id="rId36" Type="http://schemas.openxmlformats.org/officeDocument/2006/relationships/image" Target="../media/image34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31" Type="http://schemas.openxmlformats.org/officeDocument/2006/relationships/image" Target="../media/image29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emf"/><Relationship Id="rId27" Type="http://schemas.openxmlformats.org/officeDocument/2006/relationships/image" Target="../media/image25.emf"/><Relationship Id="rId30" Type="http://schemas.openxmlformats.org/officeDocument/2006/relationships/image" Target="../media/image28.emf"/><Relationship Id="rId35" Type="http://schemas.openxmlformats.org/officeDocument/2006/relationships/image" Target="../media/image33.png"/><Relationship Id="rId8" Type="http://schemas.openxmlformats.org/officeDocument/2006/relationships/image" Target="../media/image6.emf"/><Relationship Id="rId3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F95CC04-F06B-C5EA-3F43-B49D3675F1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832" y="107218"/>
            <a:ext cx="827630" cy="133208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C1ED705-2D07-6E16-DFE1-B191C32F9D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4665" y="107218"/>
            <a:ext cx="827630" cy="133603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66E27CC-36C3-BD9A-EA54-5B6D838C5D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09600" y="107218"/>
            <a:ext cx="827630" cy="133603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885F830-1F89-F335-EB09-2356EF78430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38848" y="107218"/>
            <a:ext cx="827630" cy="133603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3039055-654A-3B72-83D2-73A1446C60F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74224" y="107218"/>
            <a:ext cx="827630" cy="133603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0053C36-D17D-9160-5FC7-DE2A9B03EC7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03470" y="107218"/>
            <a:ext cx="827630" cy="133603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DE2FC3F-3A32-3CE4-3578-B978D8C9AA0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94665" y="1439307"/>
            <a:ext cx="827629" cy="133603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0F81CFD-B752-3893-58C9-8E1F86B2ACA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849333" y="1439307"/>
            <a:ext cx="827629" cy="133603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FD368BB-7BEC-707C-483E-2D647E10E4D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12867" y="1439307"/>
            <a:ext cx="827629" cy="133603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DD2E014-C50F-1EF0-8327-4268828F831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76401" y="1439307"/>
            <a:ext cx="827629" cy="133603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5D3E4A9-EFF2-3EDF-6F68-4C2A372F405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39935" y="1439307"/>
            <a:ext cx="827629" cy="133603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264EEEC-E525-E4E3-16BE-7DF3637954C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303470" y="1439307"/>
            <a:ext cx="859158" cy="133603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7F7DE51-2BE5-0D43-B437-FA6A54B34F5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22832" y="2735401"/>
            <a:ext cx="827629" cy="133603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949985C-2EF1-993A-2F49-87610398FD0E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994665" y="2735401"/>
            <a:ext cx="827629" cy="133603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00D856A-890D-1E1C-6B33-19062EB81A5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839202" y="2735401"/>
            <a:ext cx="827629" cy="133603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1E1EEF4-256E-38FF-8CD9-9D1A7550F50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697387" y="2735401"/>
            <a:ext cx="827629" cy="133603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08CD4B6F-7EAB-4666-53E9-F2270C6F5F8A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555572" y="2735401"/>
            <a:ext cx="827629" cy="133603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79BA7F6-B939-BD32-9C5B-025B3656C648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413757" y="2735401"/>
            <a:ext cx="859158" cy="133603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E906091-A614-95F9-1357-752087313965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303470" y="2735401"/>
            <a:ext cx="827629" cy="133603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32C2D09F-47F8-D52F-3D08-CBA16C5323A5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728055" y="4055422"/>
            <a:ext cx="827629" cy="133603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82086473-339B-17AF-C419-AA0BF2ECEF01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586527" y="4055422"/>
            <a:ext cx="827629" cy="133603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D794896-C3DA-58B3-402B-6DEB6E44672C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444999" y="4055422"/>
            <a:ext cx="827629" cy="133603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0D414933-43AF-237C-D99F-26D731D508C9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303470" y="4055422"/>
            <a:ext cx="827629" cy="133603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0762F789-8A0A-36A9-A0BF-B67D7BD4EF31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22832" y="5363583"/>
            <a:ext cx="827629" cy="133603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30DE2CF7-B51C-34DA-5FC9-1F6F1F725230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994665" y="5363583"/>
            <a:ext cx="827629" cy="133603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CA0B4792-B97E-DE3B-3B01-DAC4A65058B0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839202" y="5363583"/>
            <a:ext cx="827629" cy="133603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61FA518F-F6B2-4BE5-8FDF-219440A8D741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2697387" y="5363583"/>
            <a:ext cx="827629" cy="133603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26004E9D-D653-F828-D884-F197F67415B6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3555572" y="5363583"/>
            <a:ext cx="859158" cy="133603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0FA057C0-982A-6280-E340-42CAEB1547FA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4445286" y="5363583"/>
            <a:ext cx="827629" cy="133603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CE8E7E12-1C72-547B-418E-3E9A1DA719B4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122265" y="6763288"/>
            <a:ext cx="827629" cy="133603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F6DCB9B6-507C-BB2E-4D50-26F54F76E42B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994665" y="6763288"/>
            <a:ext cx="827629" cy="133603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E877493A-7960-4BB9-86A2-F5F3488AF571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1867065" y="6763288"/>
            <a:ext cx="827629" cy="1336030"/>
          </a:xfrm>
          <a:prstGeom prst="rect">
            <a:avLst/>
          </a:prstGeom>
        </p:spPr>
      </p:pic>
      <p:pic>
        <p:nvPicPr>
          <p:cNvPr id="1026" name="Picture 2" descr="https://attachments.office.net/owa/CSchurman%40buckinstitute.org/service.svc/s/GetAttachmentThumbnail?id=AAMkADQ2NTQ2MzU4LWU4YWItNDYyNi04MjdjLWRkNDY5ZThlMDZiMwBGAAAAAAAP306lWfVXR4tdjT4RncPcBwBnhSJbBYZPRbEaKYf1Wez%2BAAAAAAEMAABAYsSObCqBTb55N0vLZINFAAFUvKaRAAABEgAQAFBIcE4O76pDoK244bAegqc%3D&amp;thumbnailType=2&amp;token=eyJhbGciOiJSUzI1NiIsImtpZCI6IjczRkI5QkJFRjYzNjc4RDRGN0U4NEI0NDBCQUJCMTJBMzM5RDlGOTgiLCJ0eXAiOiJKV1QiLCJ4NXQiOiJjX3VidnZZMmVOVDM2RXRFQzZ1eEtqT2RuNWcifQ.eyJvcmlnaW4iOiJodHRwczovL291dGxvb2sub2ZmaWNlLmNvbSIsInVjIjoiYTJhMDEwZmY2YzZmNDBmZThlMTRmYmE0OTJjNGRlMjkiLCJzaWduaW5fc3RhdGUiOiJbXCJkdmNfbW5nZFwiLFwiZHZjX2NtcFwiLFwiZHZjX2RtamRcIixcImlua25vd25udHdrXCIsXCJrbXNpXCJdIiwidmVyIjoiRXhjaGFuZ2UuQ2FsbGJhY2suVjEiLCJhcHBjdHhzZW5kZXIiOiJPd2FEb3dubG9hZEAzZTllMDNlZS1iMmQyLTQ2NjctYjRmMC1lMjM3ZjNhODU5NjIiLCJpc3NyaW5nIjoiV1ciLCJhcHBjdHgiOiJ7XCJtc2V4Y2hwcm90XCI6XCJvd2FcIixcInB1aWRcIjpcIjExNTM4MDExMjIzOTEzMTk2MjJcIixcInNjb3BlXCI6XCJPd2FEb3dubG9hZFwiLFwib2lkXCI6XCI3M2RkNjU1Ni04NDM3LTQzODMtYjc0OS03NDNlYzI3MTlkMWRcIixcInByaW1hcnlzaWRcIjpcIlMtMS01LTIxLTEyMTUzMTUzODctMTgwODkzNDgwLTcwMDgxNjQzNy0zMTM2NDUxNlwifSIsIm5iZiI6MTcwMzAyNDk0NiwiZXhwIjoxNzAzMDI1NTQ2LCJpc3MiOiIwMDAwMDAwMi0wMDAwLTBmZjEtY2UwMC0wMDAwMDAwMDAwMDBAM2U5ZTAzZWUtYjJkMi00NjY3LWI0ZjAtZTIzN2YzYTg1OTYyIiwiYXVkIjoiMDAwMDAwMDItMDAwMC0wZmYxLWNlMDAtMDAwMDAwMDAwMDAwL2F0dGFjaG1lbnRzLm9mZmljZS5uZXRAM2U5ZTAzZWUtYjJkMi00NjY3LWI0ZjAtZTIzN2YzYTg1OTYyIiwiaGFwcCI6Im93YSJ9.SlWxa6dDMpKRht_Qptv4C4m1IT1ARTSWLx1Ku023nO13rbVnE5Nxyr09lF2vMQGqIwPTV0tWHQMrWhOf19ybmgiZGGy2IOmFedAKVVsujIpSLia6eAOWdv2k4z7ovrpc7zDytlHvoSa7JysOzt-2nwlAQs-EANhbW7_VFi4TnfU7nyKhxLn8_qiu_hSSNqhFdMJIG6Tkuwvc9_MG-jexDjAI2P2QpgHL-uDv2hvKZlkrrzr3o0YOSY94WK5HLq_uLPdeUrpQrAB6cilzSBGKsmDjYBP2cXDdcI4m09jfEv7Qsdc9FSygbXaX_mgbrg6JZs57YkMgax6lf36X37ObHA&amp;X-OWA-CANARY=w0qpVhESFkKDBWRuU7AFfnC9Fy_iANwY2hQbA7i5GhDQ1AOjwnOtO_dkrj9qD2Jyd_PmnLWwRpU.&amp;owa=outlook.office.com&amp;scriptVer=20231208004.04&amp;clientId=598A6DC2AF90435480FEA57304F69528&amp;animation=true">
            <a:extLst>
              <a:ext uri="{FF2B5EF4-FFF2-40B4-BE49-F238E27FC236}">
                <a16:creationId xmlns:a16="http://schemas.microsoft.com/office/drawing/2014/main" id="{4D28D358-D074-4D1C-B697-4B65591A9A7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2080" y="107218"/>
            <a:ext cx="820526" cy="13245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9DB0FD1-982A-0E0B-0CB6-4D34CF61688D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122832" y="1439307"/>
            <a:ext cx="827062" cy="1335115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0770B32B-4788-D6E7-EB5B-C0E0868E24FB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122832" y="4055422"/>
            <a:ext cx="858570" cy="1335115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20D1BC07-AE4D-A3BA-66B8-4A8FEE5C4F4D}"/>
              </a:ext>
            </a:extLst>
          </p:cNvPr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994665" y="4055422"/>
            <a:ext cx="827062" cy="1335115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F27E8889-1B45-5EF9-C2E0-7B161CE2C69D}"/>
              </a:ext>
            </a:extLst>
          </p:cNvPr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1870150" y="4055422"/>
            <a:ext cx="827062" cy="1335115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E1696209-7F8B-3A15-A7C5-45E18A20B86D}"/>
              </a:ext>
            </a:extLst>
          </p:cNvPr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5266478" y="5364498"/>
            <a:ext cx="858570" cy="13351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69475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71C89-7ACE-9400-7EB3-B9DDF14ECF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just"/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8: Tissue-matched OA Medial vs Lateral Candidate m/z Comparisons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30 of 44 candidates are significantly elevated in OA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cross the patient cohort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y paired one-sided t-test  (p&lt; 0.05). 8 additional markers nearly significant (0.1 &lt; p &lt; 0.05)</a:t>
            </a:r>
            <a:b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5638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04</TotalTime>
  <Words>51</Words>
  <Application>Microsoft Macintosh PowerPoint</Application>
  <PresentationFormat>Custom</PresentationFormat>
  <Paragraphs>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Supplemental Figure 8: Tissue-matched OA Medial vs Lateral Candidate m/z Comparisons. 30 of 44 candidates are significantly elevated in OA across the patient cohort by paired one-sided t-test  (p&lt; 0.05). 8 additional markers nearly significant (0.1 &lt; p &lt; 0.05)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ie Schurman</dc:creator>
  <cp:lastModifiedBy>Charlie Schurman</cp:lastModifiedBy>
  <cp:revision>19</cp:revision>
  <dcterms:created xsi:type="dcterms:W3CDTF">2024-02-20T19:43:53Z</dcterms:created>
  <dcterms:modified xsi:type="dcterms:W3CDTF">2024-06-18T18:57:30Z</dcterms:modified>
</cp:coreProperties>
</file>